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92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65" d="100"/>
          <a:sy n="65" d="100"/>
        </p:scale>
        <p:origin x="23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c26a16857d8080f5/Bureaublad/Book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5!$A$1:$A$18</c:f>
              <c:strCache>
                <c:ptCount val="18"/>
                <c:pt idx="0">
                  <c:v>T cell activation</c:v>
                </c:pt>
                <c:pt idx="1">
                  <c:v>positive regulation of cellular component movement</c:v>
                </c:pt>
                <c:pt idx="2">
                  <c:v>positive regulation of cell motility</c:v>
                </c:pt>
                <c:pt idx="3">
                  <c:v>leukocyte differentiation</c:v>
                </c:pt>
                <c:pt idx="4">
                  <c:v>response to bacterium</c:v>
                </c:pt>
                <c:pt idx="5">
                  <c:v>myeloid leukocyte differentiation</c:v>
                </c:pt>
                <c:pt idx="6">
                  <c:v>osteoclast differentiation</c:v>
                </c:pt>
                <c:pt idx="7">
                  <c:v>chemokine-mediated signaling pathway</c:v>
                </c:pt>
                <c:pt idx="8">
                  <c:v>inflammatory response</c:v>
                </c:pt>
                <c:pt idx="9">
                  <c:v>granulocyte activation</c:v>
                </c:pt>
                <c:pt idx="10">
                  <c:v>neutrophil mediated immunity</c:v>
                </c:pt>
                <c:pt idx="11">
                  <c:v>neutrophil activation</c:v>
                </c:pt>
                <c:pt idx="12">
                  <c:v>neutrophil activation involved in immune response</c:v>
                </c:pt>
                <c:pt idx="13">
                  <c:v>neutrophil degranulation</c:v>
                </c:pt>
                <c:pt idx="14">
                  <c:v>myeloid leukocyte mediated immunity</c:v>
                </c:pt>
                <c:pt idx="15">
                  <c:v>myeloid cell activation involved in immune response</c:v>
                </c:pt>
                <c:pt idx="16">
                  <c:v>leukocyte degranulation</c:v>
                </c:pt>
                <c:pt idx="17">
                  <c:v>myeloid leukocyte activation</c:v>
                </c:pt>
              </c:strCache>
            </c:strRef>
          </c:cat>
          <c:val>
            <c:numRef>
              <c:f>Sheet5!$B$1:$B$18</c:f>
              <c:numCache>
                <c:formatCode>General</c:formatCode>
                <c:ptCount val="18"/>
                <c:pt idx="0">
                  <c:v>4.3204844450842659</c:v>
                </c:pt>
                <c:pt idx="1">
                  <c:v>4.3266335792262032</c:v>
                </c:pt>
                <c:pt idx="2">
                  <c:v>4.4280900926377535</c:v>
                </c:pt>
                <c:pt idx="3">
                  <c:v>4.4669176616488819</c:v>
                </c:pt>
                <c:pt idx="4">
                  <c:v>4.5726200094742859</c:v>
                </c:pt>
                <c:pt idx="5">
                  <c:v>4.8882627422930938</c:v>
                </c:pt>
                <c:pt idx="6">
                  <c:v>5.3640927586391687</c:v>
                </c:pt>
                <c:pt idx="7">
                  <c:v>5.4479791922439338</c:v>
                </c:pt>
                <c:pt idx="8">
                  <c:v>7.0119763791574483</c:v>
                </c:pt>
                <c:pt idx="9">
                  <c:v>8.3439799768398721</c:v>
                </c:pt>
                <c:pt idx="10">
                  <c:v>8.362759984995396</c:v>
                </c:pt>
                <c:pt idx="11">
                  <c:v>8.4384853180797776</c:v>
                </c:pt>
                <c:pt idx="12">
                  <c:v>8.5733863519120028</c:v>
                </c:pt>
                <c:pt idx="13">
                  <c:v>8.5929108510385195</c:v>
                </c:pt>
                <c:pt idx="14">
                  <c:v>9.3261101996809526</c:v>
                </c:pt>
                <c:pt idx="15">
                  <c:v>9.4614432724406878</c:v>
                </c:pt>
                <c:pt idx="16">
                  <c:v>9.5006262027714961</c:v>
                </c:pt>
                <c:pt idx="17">
                  <c:v>10.0177961117154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50-4804-A3F0-F3D53EFBF6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31024440"/>
        <c:axId val="631024768"/>
      </c:barChart>
      <c:catAx>
        <c:axId val="631024440"/>
        <c:scaling>
          <c:orientation val="minMax"/>
        </c:scaling>
        <c:delete val="0"/>
        <c:axPos val="l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BE"/>
          </a:p>
        </c:txPr>
        <c:crossAx val="631024768"/>
        <c:crosses val="autoZero"/>
        <c:auto val="1"/>
        <c:lblAlgn val="ctr"/>
        <c:lblOffset val="100"/>
        <c:noMultiLvlLbl val="0"/>
      </c:catAx>
      <c:valAx>
        <c:axId val="631024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BE"/>
          </a:p>
        </c:txPr>
        <c:crossAx val="631024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B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902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93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122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283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72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09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416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499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00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537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884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33140-D675-41B3-8372-A760330FFD9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2EDDF-1FD3-4EDC-9F64-5C88D3B00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302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7679" y="183505"/>
            <a:ext cx="12314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nl-BE" sz="1100" b="1" dirty="0">
                <a:latin typeface="Arial" panose="020B0604020202020204" pitchFamily="34" charset="0"/>
                <a:cs typeface="Arial" panose="020B0604020202020204" pitchFamily="34" charset="0"/>
              </a:rPr>
              <a:t> file 8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25664" y="28974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4665054" y="4053990"/>
            <a:ext cx="1356024" cy="506225"/>
            <a:chOff x="5069010" y="2929970"/>
            <a:chExt cx="1356024" cy="50622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2638" y="3089625"/>
              <a:ext cx="1162998" cy="73674"/>
            </a:xfrm>
            <a:prstGeom prst="rect">
              <a:avLst/>
            </a:prstGeom>
          </p:spPr>
        </p:pic>
        <p:sp>
          <p:nvSpPr>
            <p:cNvPr id="83" name="TextBox 82"/>
            <p:cNvSpPr txBox="1"/>
            <p:nvPr/>
          </p:nvSpPr>
          <p:spPr>
            <a:xfrm>
              <a:off x="5560482" y="2929970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FDR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627006" y="312841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5961445" y="3128418"/>
              <a:ext cx="4635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  <a:p>
              <a:pPr algn="r"/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PMWS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069010" y="3128418"/>
              <a:ext cx="4876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  <a:p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2610879" y="28974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568314" y="3188541"/>
            <a:ext cx="1945891" cy="5284368"/>
            <a:chOff x="319528" y="3136183"/>
            <a:chExt cx="1945891" cy="5284368"/>
          </a:xfrm>
        </p:grpSpPr>
        <p:grpSp>
          <p:nvGrpSpPr>
            <p:cNvPr id="27" name="Group 26"/>
            <p:cNvGrpSpPr/>
            <p:nvPr/>
          </p:nvGrpSpPr>
          <p:grpSpPr>
            <a:xfrm>
              <a:off x="319528" y="3136183"/>
              <a:ext cx="1757068" cy="5284368"/>
              <a:chOff x="319528" y="3136183"/>
              <a:chExt cx="1757068" cy="5284368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319528" y="3136183"/>
                <a:ext cx="1691868" cy="5284368"/>
                <a:chOff x="568111" y="2693536"/>
                <a:chExt cx="1691868" cy="5284368"/>
              </a:xfrm>
            </p:grpSpPr>
            <p:sp>
              <p:nvSpPr>
                <p:cNvPr id="56" name="TextBox 55"/>
                <p:cNvSpPr txBox="1"/>
                <p:nvPr/>
              </p:nvSpPr>
              <p:spPr>
                <a:xfrm>
                  <a:off x="954116" y="7777849"/>
                  <a:ext cx="128670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nl-B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lidation set</a:t>
                  </a: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570515" y="3011221"/>
                  <a:ext cx="43954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tus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570515" y="3146419"/>
                  <a:ext cx="3626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TP</a:t>
                  </a: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568111" y="3281618"/>
                  <a:ext cx="36740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DR</a:t>
                  </a: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 rot="16200000">
                  <a:off x="817181" y="2799655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3</a:t>
                  </a: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 rot="16200000">
                  <a:off x="979556" y="2799655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4</a:t>
                  </a: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 rot="16200000">
                  <a:off x="1141931" y="2799655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1</a:t>
                  </a: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 rot="16200000">
                  <a:off x="1304306" y="2799656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6</a:t>
                  </a: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 rot="16200000">
                  <a:off x="1466681" y="2799656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5</a:t>
                  </a:r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 rot="16200000">
                  <a:off x="1629055" y="2799655"/>
                  <a:ext cx="41229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2</a:t>
                  </a: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 rot="16200000">
                  <a:off x="1791430" y="2799655"/>
                  <a:ext cx="41229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7</a:t>
                  </a:r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 rot="16200000">
                  <a:off x="1953805" y="2799655"/>
                  <a:ext cx="41229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_C8</a:t>
                  </a:r>
                </a:p>
              </p:txBody>
            </p:sp>
          </p:grpSp>
          <p:sp>
            <p:nvSpPr>
              <p:cNvPr id="26" name="Rectangle 25"/>
              <p:cNvSpPr/>
              <p:nvPr/>
            </p:nvSpPr>
            <p:spPr>
              <a:xfrm>
                <a:off x="1998949" y="3941948"/>
                <a:ext cx="77647" cy="2147702"/>
              </a:xfrm>
              <a:prstGeom prst="rect">
                <a:avLst/>
              </a:prstGeom>
              <a:solidFill>
                <a:srgbClr val="FE920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105"/>
              <p:cNvSpPr/>
              <p:nvPr/>
            </p:nvSpPr>
            <p:spPr>
              <a:xfrm>
                <a:off x="1998949" y="6089650"/>
                <a:ext cx="77647" cy="2095676"/>
              </a:xfrm>
              <a:prstGeom prst="rect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9" name="TextBox 108"/>
            <p:cNvSpPr txBox="1"/>
            <p:nvPr/>
          </p:nvSpPr>
          <p:spPr>
            <a:xfrm rot="16200000">
              <a:off x="1786923" y="7086998"/>
              <a:ext cx="7569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Healthy genes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 rot="16200000">
              <a:off x="1798945" y="4897277"/>
              <a:ext cx="7328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PMWS genes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837222" y="2903593"/>
            <a:ext cx="1583222" cy="5569316"/>
            <a:chOff x="2588436" y="2851235"/>
            <a:chExt cx="1583222" cy="5569316"/>
          </a:xfrm>
        </p:grpSpPr>
        <p:sp>
          <p:nvSpPr>
            <p:cNvPr id="57" name="TextBox 56"/>
            <p:cNvSpPr txBox="1"/>
            <p:nvPr/>
          </p:nvSpPr>
          <p:spPr>
            <a:xfrm>
              <a:off x="2610301" y="8220496"/>
              <a:ext cx="1278866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700" dirty="0">
                  <a:latin typeface="Arial" panose="020B0604020202020204" pitchFamily="34" charset="0"/>
                  <a:cs typeface="Arial" panose="020B0604020202020204" pitchFamily="34" charset="0"/>
                </a:rPr>
                <a:t>Experimental study 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2417396" y="3206745"/>
              <a:ext cx="542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NI29dpi1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2579770" y="3206745"/>
              <a:ext cx="542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NI29dpi4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2675623" y="3140221"/>
              <a:ext cx="67518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ubcl29dpi2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2904522" y="3206745"/>
              <a:ext cx="542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NI29dpi2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 rot="16200000">
              <a:off x="3066896" y="3206745"/>
              <a:ext cx="542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NI29dpi3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3137038" y="3114511"/>
              <a:ext cx="72660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ubcl29dpi3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3299410" y="3114511"/>
              <a:ext cx="7266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ubcl29dpi4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 rot="16200000">
              <a:off x="3461785" y="3114510"/>
              <a:ext cx="7266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ubcl29dpi1</a:t>
              </a:r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3911031" y="3941948"/>
              <a:ext cx="77647" cy="2147702"/>
            </a:xfrm>
            <a:prstGeom prst="rect">
              <a:avLst/>
            </a:prstGeom>
            <a:solidFill>
              <a:srgbClr val="FE920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3911032" y="6089651"/>
              <a:ext cx="77647" cy="20956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6200000">
              <a:off x="3693162" y="7086997"/>
              <a:ext cx="7569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Healthy genes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3705184" y="4915771"/>
              <a:ext cx="7328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PMWS genes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4689016" y="3413328"/>
            <a:ext cx="641354" cy="463913"/>
            <a:chOff x="639159" y="6232932"/>
            <a:chExt cx="641354" cy="463913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2180" y="6410031"/>
              <a:ext cx="116953" cy="250614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792879" y="6375005"/>
              <a:ext cx="4876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792879" y="6496790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PMWS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39159" y="6232932"/>
              <a:ext cx="4395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tatus</a:t>
              </a:r>
            </a:p>
          </p:txBody>
        </p:sp>
      </p:grp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854" y="3546812"/>
            <a:ext cx="1283716" cy="469087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6662" y="3552811"/>
            <a:ext cx="1283716" cy="469087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638615" y="445289"/>
            <a:ext cx="22701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700" dirty="0">
                <a:latin typeface="Arial" panose="020B0604020202020204" pitchFamily="34" charset="0"/>
                <a:cs typeface="Arial" panose="020B0604020202020204" pitchFamily="34" charset="0"/>
              </a:rPr>
              <a:t>PMWS biomarker genes GO overrepresentation test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25664" y="51545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532620" y="6208453"/>
            <a:ext cx="1653744" cy="2416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8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MWS biomarker genes annotation and performance of an alternative clinical disease signature.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 ontology (GO) terms overrepresentation test of PMWS biomarker genes.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earest Template Prediction of test set samples using an alternative gene clinical gene signature based on the RNMI metric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imilarly, of the experimental subclinical infection samples at 29dpi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F877ECE6-2BE5-467B-88D3-47C68B44DDA8}"/>
              </a:ext>
            </a:extLst>
          </p:cNvPr>
          <p:cNvGrpSpPr/>
          <p:nvPr/>
        </p:nvGrpSpPr>
        <p:grpSpPr>
          <a:xfrm>
            <a:off x="613346" y="556331"/>
            <a:ext cx="5246821" cy="2416121"/>
            <a:chOff x="613346" y="556331"/>
            <a:chExt cx="5246821" cy="2416121"/>
          </a:xfrm>
        </p:grpSpPr>
        <p:sp>
          <p:nvSpPr>
            <p:cNvPr id="78" name="TextBox 77"/>
            <p:cNvSpPr txBox="1"/>
            <p:nvPr/>
          </p:nvSpPr>
          <p:spPr>
            <a:xfrm>
              <a:off x="5440733" y="2757008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>
                  <a:latin typeface="Arial" panose="020B0604020202020204" pitchFamily="34" charset="0"/>
                  <a:cs typeface="Arial" panose="020B0604020202020204" pitchFamily="34" charset="0"/>
                </a:rPr>
                <a:t>FDR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16200000">
              <a:off x="270944" y="1444493"/>
              <a:ext cx="915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>
                  <a:latin typeface="Arial" panose="020B0604020202020204" pitchFamily="34" charset="0"/>
                  <a:cs typeface="Arial" panose="020B0604020202020204" pitchFamily="34" charset="0"/>
                </a:rPr>
                <a:t>GO_bp Terms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9" name="Chart 58">
              <a:extLst>
                <a:ext uri="{FF2B5EF4-FFF2-40B4-BE49-F238E27FC236}">
                  <a16:creationId xmlns:a16="http://schemas.microsoft.com/office/drawing/2014/main" id="{B51B5B16-F62B-4826-AA69-1652B1974FC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98385486"/>
                </p:ext>
              </p:extLst>
            </p:nvPr>
          </p:nvGraphicFramePr>
          <p:xfrm>
            <a:off x="846207" y="556331"/>
            <a:ext cx="5013960" cy="23005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539189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3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as</dc:creator>
  <cp:lastModifiedBy>Nicolaas Van Renne</cp:lastModifiedBy>
  <cp:revision>122</cp:revision>
  <dcterms:created xsi:type="dcterms:W3CDTF">2015-02-12T13:37:42Z</dcterms:created>
  <dcterms:modified xsi:type="dcterms:W3CDTF">2018-10-04T14:15:30Z</dcterms:modified>
</cp:coreProperties>
</file>